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2" d="100"/>
          <a:sy n="82" d="100"/>
        </p:scale>
        <p:origin x="691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altLang="zh-CN" b="1" dirty="0" smtClean="0">
                <a:solidFill>
                  <a:schemeClr val="tx1"/>
                </a:solidFill>
              </a:rPr>
              <a:t>Protoplast </a:t>
            </a:r>
            <a:r>
              <a:rPr lang="en-GB" altLang="zh-CN" b="1" dirty="0">
                <a:solidFill>
                  <a:schemeClr val="tx1"/>
                </a:solidFill>
              </a:rPr>
              <a:t>1</a:t>
            </a:r>
            <a:endParaRPr lang="zh-CN" altLang="en-US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5.6623119370929377E-2"/>
          <c:y val="6.60766838869887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6077209098862652E-2"/>
          <c:y val="0.17171296296296296"/>
          <c:w val="0.84280869695161653"/>
          <c:h val="0.77736111111111106"/>
        </c:manualLayout>
      </c:layout>
      <c:scatterChart>
        <c:scatterStyle val="smooth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D$27:$D$40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E$27:$E$40</c:f>
              <c:numCache>
                <c:formatCode>General</c:formatCode>
                <c:ptCount val="14"/>
                <c:pt idx="0">
                  <c:v>-470.92790000000002</c:v>
                </c:pt>
                <c:pt idx="1">
                  <c:v>-419.41019999999997</c:v>
                </c:pt>
                <c:pt idx="2">
                  <c:v>-374.4753</c:v>
                </c:pt>
                <c:pt idx="3">
                  <c:v>-330.57670000000002</c:v>
                </c:pt>
                <c:pt idx="4">
                  <c:v>-289.1891</c:v>
                </c:pt>
                <c:pt idx="5">
                  <c:v>-245.04329999999999</c:v>
                </c:pt>
                <c:pt idx="6">
                  <c:v>-198.09190000000001</c:v>
                </c:pt>
                <c:pt idx="7">
                  <c:v>-138.5993</c:v>
                </c:pt>
                <c:pt idx="8">
                  <c:v>-54.514299999999999</c:v>
                </c:pt>
                <c:pt idx="9">
                  <c:v>60.095399999999998</c:v>
                </c:pt>
                <c:pt idx="10">
                  <c:v>207.18129999999999</c:v>
                </c:pt>
                <c:pt idx="11">
                  <c:v>379.20209999999997</c:v>
                </c:pt>
                <c:pt idx="12">
                  <c:v>558.70759999999996</c:v>
                </c:pt>
                <c:pt idx="13">
                  <c:v>692.645200000000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B62B-4BB0-9A13-D8F03B0F532C}"/>
            </c:ext>
          </c:extLst>
        </c:ser>
        <c:ser>
          <c:idx val="1"/>
          <c:order val="1"/>
          <c:tx>
            <c:v>ATP (3 mins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D$74:$D$87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E$74:$E$87</c:f>
              <c:numCache>
                <c:formatCode>General</c:formatCode>
                <c:ptCount val="14"/>
                <c:pt idx="0">
                  <c:v>-805.65160000000003</c:v>
                </c:pt>
                <c:pt idx="1">
                  <c:v>-715.37909999999999</c:v>
                </c:pt>
                <c:pt idx="2">
                  <c:v>-633.51890000000003</c:v>
                </c:pt>
                <c:pt idx="3">
                  <c:v>-559.87750000000005</c:v>
                </c:pt>
                <c:pt idx="4">
                  <c:v>-486.05840000000001</c:v>
                </c:pt>
                <c:pt idx="5">
                  <c:v>-403.78750000000002</c:v>
                </c:pt>
                <c:pt idx="6">
                  <c:v>-308.3886</c:v>
                </c:pt>
                <c:pt idx="7">
                  <c:v>-198.17930000000001</c:v>
                </c:pt>
                <c:pt idx="8">
                  <c:v>-70.513400000000004</c:v>
                </c:pt>
                <c:pt idx="9">
                  <c:v>80.5608</c:v>
                </c:pt>
                <c:pt idx="10">
                  <c:v>258.87860000000001</c:v>
                </c:pt>
                <c:pt idx="11">
                  <c:v>460.78590000000003</c:v>
                </c:pt>
                <c:pt idx="12">
                  <c:v>678.23850000000004</c:v>
                </c:pt>
                <c:pt idx="13">
                  <c:v>888.3333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B62B-4BB0-9A13-D8F03B0F53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60011872"/>
        <c:axId val="-298865392"/>
      </c:scatterChart>
      <c:valAx>
        <c:axId val="-5600118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err="1" smtClean="0">
                    <a:solidFill>
                      <a:schemeClr val="tx1"/>
                    </a:solidFill>
                  </a:rPr>
                  <a:t>Vm</a:t>
                </a:r>
                <a:r>
                  <a:rPr lang="en-US" b="1" dirty="0" smtClean="0">
                    <a:solidFill>
                      <a:schemeClr val="tx1"/>
                    </a:solidFill>
                  </a:rPr>
                  <a:t> (mV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9039661598571514E-2"/>
              <c:y val="0.479858317913582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98865392"/>
        <c:crosses val="autoZero"/>
        <c:crossBetween val="midCat"/>
      </c:valAx>
      <c:valAx>
        <c:axId val="-298865392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smtClean="0">
                    <a:solidFill>
                      <a:schemeClr val="tx1"/>
                    </a:solidFill>
                  </a:rPr>
                  <a:t>I (</a:t>
                </a:r>
                <a:r>
                  <a:rPr lang="en-US" b="1" dirty="0" err="1" smtClean="0">
                    <a:solidFill>
                      <a:schemeClr val="tx1"/>
                    </a:solidFill>
                  </a:rPr>
                  <a:t>pA</a:t>
                </a:r>
                <a:r>
                  <a:rPr lang="en-US" b="1" dirty="0" smtClean="0">
                    <a:solidFill>
                      <a:schemeClr val="tx1"/>
                    </a:solidFill>
                  </a:rPr>
                  <a:t>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6160165295746749"/>
              <c:y val="6.982090542895401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60011872"/>
        <c:crosses val="autoZero"/>
        <c:crossBetween val="midCat"/>
        <c:majorUnit val="500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2118324878024305"/>
          <c:y val="0.19450961475212133"/>
          <c:w val="0.3309795360069635"/>
          <c:h val="0.192331462647162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altLang="zh-CN" b="1" i="0" dirty="0" smtClean="0">
                <a:solidFill>
                  <a:schemeClr val="tx1"/>
                </a:solidFill>
              </a:rPr>
              <a:t>Protoplast</a:t>
            </a:r>
            <a:r>
              <a:rPr lang="en-GB" altLang="zh-CN" b="1" i="0" baseline="0" dirty="0" smtClean="0">
                <a:solidFill>
                  <a:schemeClr val="tx1"/>
                </a:solidFill>
              </a:rPr>
              <a:t> </a:t>
            </a:r>
            <a:r>
              <a:rPr lang="en-GB" altLang="zh-CN" b="1" i="0" dirty="0" smtClean="0">
                <a:solidFill>
                  <a:schemeClr val="tx1"/>
                </a:solidFill>
              </a:rPr>
              <a:t>2</a:t>
            </a:r>
            <a:endParaRPr lang="zh-CN" altLang="en-US" b="1" i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1410237988693787E-2"/>
          <c:y val="7.10479441223770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7270778652668423E-2"/>
          <c:y val="0.1902314814814815"/>
          <c:w val="0.89706255468066487"/>
          <c:h val="0.77736111111111106"/>
        </c:manualLayout>
      </c:layout>
      <c:scatterChart>
        <c:scatterStyle val="smooth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D$27:$D$40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F$27:$F$40</c:f>
              <c:numCache>
                <c:formatCode>General</c:formatCode>
                <c:ptCount val="14"/>
                <c:pt idx="0">
                  <c:v>-291.60000000000002</c:v>
                </c:pt>
                <c:pt idx="1">
                  <c:v>-261.26659999999998</c:v>
                </c:pt>
                <c:pt idx="2">
                  <c:v>-232.4</c:v>
                </c:pt>
                <c:pt idx="3">
                  <c:v>-203.99260000000001</c:v>
                </c:pt>
                <c:pt idx="4">
                  <c:v>-176.7407</c:v>
                </c:pt>
                <c:pt idx="5">
                  <c:v>-148.76300000000001</c:v>
                </c:pt>
                <c:pt idx="6">
                  <c:v>-118.7259</c:v>
                </c:pt>
                <c:pt idx="7">
                  <c:v>-85.118499999999997</c:v>
                </c:pt>
                <c:pt idx="8">
                  <c:v>-46.348100000000002</c:v>
                </c:pt>
                <c:pt idx="9">
                  <c:v>-0.58520000000000005</c:v>
                </c:pt>
                <c:pt idx="10">
                  <c:v>59.036999999999999</c:v>
                </c:pt>
                <c:pt idx="11">
                  <c:v>141.13329999999999</c:v>
                </c:pt>
                <c:pt idx="12">
                  <c:v>245.8</c:v>
                </c:pt>
                <c:pt idx="13">
                  <c:v>359.5480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7EA7-4E5F-8F53-0D58F722B3DE}"/>
            </c:ext>
          </c:extLst>
        </c:ser>
        <c:ser>
          <c:idx val="1"/>
          <c:order val="1"/>
          <c:tx>
            <c:v>ATP (3 mins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D$74:$D$87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F$74:$F$87</c:f>
              <c:numCache>
                <c:formatCode>General</c:formatCode>
                <c:ptCount val="14"/>
                <c:pt idx="0">
                  <c:v>-459.98320000000001</c:v>
                </c:pt>
                <c:pt idx="1">
                  <c:v>-396.57190000000003</c:v>
                </c:pt>
                <c:pt idx="2">
                  <c:v>-341.69729999999998</c:v>
                </c:pt>
                <c:pt idx="3">
                  <c:v>-295.61869999999999</c:v>
                </c:pt>
                <c:pt idx="4">
                  <c:v>-251.1455</c:v>
                </c:pt>
                <c:pt idx="5">
                  <c:v>-210.5017</c:v>
                </c:pt>
                <c:pt idx="6">
                  <c:v>-170.9699</c:v>
                </c:pt>
                <c:pt idx="7">
                  <c:v>-127.16549999999999</c:v>
                </c:pt>
                <c:pt idx="8">
                  <c:v>-72.792599999999993</c:v>
                </c:pt>
                <c:pt idx="9">
                  <c:v>-0.24249999999999999</c:v>
                </c:pt>
                <c:pt idx="10">
                  <c:v>92.968199999999996</c:v>
                </c:pt>
                <c:pt idx="11">
                  <c:v>206.95650000000001</c:v>
                </c:pt>
                <c:pt idx="12">
                  <c:v>333.94650000000001</c:v>
                </c:pt>
                <c:pt idx="13">
                  <c:v>464.6070000000000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7EA7-4E5F-8F53-0D58F722B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222688"/>
        <c:axId val="-208219968"/>
      </c:scatterChart>
      <c:valAx>
        <c:axId val="-2082226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err="1" smtClean="0">
                    <a:solidFill>
                      <a:schemeClr val="tx1"/>
                    </a:solidFill>
                  </a:rPr>
                  <a:t>Vm</a:t>
                </a:r>
                <a:r>
                  <a:rPr lang="en-US" b="1" dirty="0" smtClean="0">
                    <a:solidFill>
                      <a:schemeClr val="tx1"/>
                    </a:solidFill>
                  </a:rPr>
                  <a:t> (mV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5.7805895047410259E-2"/>
              <c:y val="0.49695668648798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219968"/>
        <c:crosses val="autoZero"/>
        <c:crossBetween val="midCat"/>
      </c:valAx>
      <c:valAx>
        <c:axId val="-208219968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dirty="0" smtClean="0">
                    <a:solidFill>
                      <a:schemeClr val="tx1"/>
                    </a:solidFill>
                  </a:rPr>
                  <a:t>I</a:t>
                </a:r>
                <a:r>
                  <a:rPr lang="en-US" sz="1000" b="1" baseline="0" dirty="0" smtClean="0">
                    <a:solidFill>
                      <a:schemeClr val="tx1"/>
                    </a:solidFill>
                  </a:rPr>
                  <a:t> (</a:t>
                </a:r>
                <a:r>
                  <a:rPr lang="en-US" sz="1000" b="1" baseline="0" dirty="0" err="1" smtClean="0">
                    <a:solidFill>
                      <a:schemeClr val="tx1"/>
                    </a:solidFill>
                  </a:rPr>
                  <a:t>pA</a:t>
                </a:r>
                <a:r>
                  <a:rPr lang="en-US" sz="1000" b="1" baseline="0" dirty="0" smtClean="0">
                    <a:solidFill>
                      <a:schemeClr val="tx1"/>
                    </a:solidFill>
                  </a:rPr>
                  <a:t>)</a:t>
                </a:r>
                <a:endParaRPr lang="en-US" sz="1000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63009378049097575"/>
              <c:y val="9.017308099689401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2226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20775259357180098"/>
          <c:y val="0.18985278716795809"/>
          <c:w val="0.33546785558379144"/>
          <c:h val="0.245116526087462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altLang="zh-CN" b="1" baseline="0" dirty="0" smtClean="0">
                <a:solidFill>
                  <a:schemeClr val="tx1"/>
                </a:solidFill>
              </a:rPr>
              <a:t>Protoplast 3</a:t>
            </a:r>
            <a:endParaRPr lang="zh-CN" altLang="en-US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5.6623376623376631E-2"/>
          <c:y val="8.67992601938820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2841207349081347E-2"/>
          <c:y val="0.17171296296296296"/>
          <c:w val="0.82258172273920305"/>
          <c:h val="0.70579872975395852"/>
        </c:manualLayout>
      </c:layout>
      <c:scatterChart>
        <c:scatterStyle val="smooth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D$27:$D$40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G$27:$G$40</c:f>
              <c:numCache>
                <c:formatCode>General</c:formatCode>
                <c:ptCount val="14"/>
                <c:pt idx="0">
                  <c:v>-77.539100000000005</c:v>
                </c:pt>
                <c:pt idx="1">
                  <c:v>-70.191000000000003</c:v>
                </c:pt>
                <c:pt idx="2">
                  <c:v>-62.456600000000002</c:v>
                </c:pt>
                <c:pt idx="3">
                  <c:v>-55.772599999999997</c:v>
                </c:pt>
                <c:pt idx="4">
                  <c:v>-48.784700000000001</c:v>
                </c:pt>
                <c:pt idx="5">
                  <c:v>-41.527799999999999</c:v>
                </c:pt>
                <c:pt idx="6">
                  <c:v>-34.019100000000002</c:v>
                </c:pt>
                <c:pt idx="7">
                  <c:v>-24.509499999999999</c:v>
                </c:pt>
                <c:pt idx="8">
                  <c:v>-14.2491</c:v>
                </c:pt>
                <c:pt idx="9">
                  <c:v>-0.25169999999999998</c:v>
                </c:pt>
                <c:pt idx="10">
                  <c:v>15.1302</c:v>
                </c:pt>
                <c:pt idx="11">
                  <c:v>34.874099999999999</c:v>
                </c:pt>
                <c:pt idx="12">
                  <c:v>57.556399999999996</c:v>
                </c:pt>
                <c:pt idx="13">
                  <c:v>87.8516000000000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BD0D-42F5-BF81-3A209777C627}"/>
            </c:ext>
          </c:extLst>
        </c:ser>
        <c:ser>
          <c:idx val="1"/>
          <c:order val="1"/>
          <c:tx>
            <c:v>ATP (3 mins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D$74:$D$87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G$74:$G$87</c:f>
              <c:numCache>
                <c:formatCode>General</c:formatCode>
                <c:ptCount val="14"/>
                <c:pt idx="0">
                  <c:v>-127.661</c:v>
                </c:pt>
                <c:pt idx="1">
                  <c:v>-112.58499999999999</c:v>
                </c:pt>
                <c:pt idx="2">
                  <c:v>-96.185100000000006</c:v>
                </c:pt>
                <c:pt idx="3">
                  <c:v>-83.828299999999999</c:v>
                </c:pt>
                <c:pt idx="4">
                  <c:v>-71.914100000000005</c:v>
                </c:pt>
                <c:pt idx="5">
                  <c:v>-59.897100000000002</c:v>
                </c:pt>
                <c:pt idx="6">
                  <c:v>-47.061700000000002</c:v>
                </c:pt>
                <c:pt idx="7">
                  <c:v>-34.078699999999998</c:v>
                </c:pt>
                <c:pt idx="8">
                  <c:v>-19.2531</c:v>
                </c:pt>
                <c:pt idx="9">
                  <c:v>-2.5</c:v>
                </c:pt>
                <c:pt idx="10">
                  <c:v>17.723600000000001</c:v>
                </c:pt>
                <c:pt idx="11">
                  <c:v>41.721800000000002</c:v>
                </c:pt>
                <c:pt idx="12">
                  <c:v>72.397099999999995</c:v>
                </c:pt>
                <c:pt idx="13">
                  <c:v>109.6958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BD0D-42F5-BF81-3A209777C6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221600"/>
        <c:axId val="-208218880"/>
      </c:scatterChart>
      <c:valAx>
        <c:axId val="-2082216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err="1" smtClean="0">
                    <a:solidFill>
                      <a:schemeClr val="tx1"/>
                    </a:solidFill>
                  </a:rPr>
                  <a:t>Vm</a:t>
                </a:r>
                <a:r>
                  <a:rPr lang="en-US" b="1" dirty="0" smtClean="0">
                    <a:solidFill>
                      <a:schemeClr val="tx1"/>
                    </a:solidFill>
                  </a:rPr>
                  <a:t> (mV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8.7811569008419424E-2"/>
              <c:y val="0.454104796247659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218880"/>
        <c:crosses val="autoZero"/>
        <c:crossBetween val="midCat"/>
      </c:valAx>
      <c:valAx>
        <c:axId val="-208218880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 smtClean="0">
                    <a:solidFill>
                      <a:schemeClr val="tx1"/>
                    </a:solidFill>
                  </a:rPr>
                  <a:t>I (</a:t>
                </a:r>
                <a:r>
                  <a:rPr lang="en-US" b="1" dirty="0" err="1" smtClean="0">
                    <a:solidFill>
                      <a:schemeClr val="tx1"/>
                    </a:solidFill>
                  </a:rPr>
                  <a:t>pA</a:t>
                </a:r>
                <a:r>
                  <a:rPr lang="en-US" b="1" dirty="0" smtClean="0">
                    <a:solidFill>
                      <a:schemeClr val="tx1"/>
                    </a:solidFill>
                  </a:rPr>
                  <a:t>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60507482019293046"/>
              <c:y val="7.402769450761163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2216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21583692947472474"/>
          <c:y val="0.19966791499140171"/>
          <c:w val="0.33802720114531137"/>
          <c:h val="0.162749751961431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altLang="zh-CN" b="1" dirty="0" smtClean="0">
                <a:solidFill>
                  <a:schemeClr val="tx1"/>
                </a:solidFill>
              </a:rPr>
              <a:t>Protoplast </a:t>
            </a:r>
            <a:r>
              <a:rPr lang="en-GB" altLang="zh-CN" b="1" dirty="0">
                <a:solidFill>
                  <a:schemeClr val="tx1"/>
                </a:solidFill>
              </a:rPr>
              <a:t>4</a:t>
            </a:r>
            <a:endParaRPr lang="zh-CN" altLang="en-US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4.519671624106715E-2"/>
          <c:y val="1.47469276266464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2484731490435132E-2"/>
          <c:y val="0.11182048703490179"/>
          <c:w val="0.89260333493167832"/>
          <c:h val="0.77436412548220168"/>
        </c:manualLayout>
      </c:layout>
      <c:scatterChart>
        <c:scatterStyle val="smooth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D$27:$D$40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H$27:$H$40</c:f>
              <c:numCache>
                <c:formatCode>General</c:formatCode>
                <c:ptCount val="14"/>
                <c:pt idx="0">
                  <c:v>-81.382000000000005</c:v>
                </c:pt>
                <c:pt idx="1">
                  <c:v>-73.125</c:v>
                </c:pt>
                <c:pt idx="2">
                  <c:v>-64.969200000000001</c:v>
                </c:pt>
                <c:pt idx="3">
                  <c:v>-56.694499999999998</c:v>
                </c:pt>
                <c:pt idx="4">
                  <c:v>-49.031700000000001</c:v>
                </c:pt>
                <c:pt idx="5">
                  <c:v>-40.972700000000003</c:v>
                </c:pt>
                <c:pt idx="6">
                  <c:v>-32.9709</c:v>
                </c:pt>
                <c:pt idx="7">
                  <c:v>-24.159300000000002</c:v>
                </c:pt>
                <c:pt idx="8">
                  <c:v>-14.797499999999999</c:v>
                </c:pt>
                <c:pt idx="9">
                  <c:v>-4.1901000000000002</c:v>
                </c:pt>
                <c:pt idx="10">
                  <c:v>9.0713000000000008</c:v>
                </c:pt>
                <c:pt idx="11">
                  <c:v>24.511399999999998</c:v>
                </c:pt>
                <c:pt idx="12">
                  <c:v>44.9604</c:v>
                </c:pt>
                <c:pt idx="13">
                  <c:v>70.4840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E114-42E8-A1A7-02CC8B32FC1B}"/>
            </c:ext>
          </c:extLst>
        </c:ser>
        <c:ser>
          <c:idx val="1"/>
          <c:order val="1"/>
          <c:tx>
            <c:v>ATP (3 mins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D$74:$D$87</c:f>
              <c:numCache>
                <c:formatCode>General</c:formatCode>
                <c:ptCount val="14"/>
                <c:pt idx="0">
                  <c:v>-217</c:v>
                </c:pt>
                <c:pt idx="1">
                  <c:v>-197</c:v>
                </c:pt>
                <c:pt idx="2">
                  <c:v>-177</c:v>
                </c:pt>
                <c:pt idx="3">
                  <c:v>-157</c:v>
                </c:pt>
                <c:pt idx="4">
                  <c:v>-137</c:v>
                </c:pt>
                <c:pt idx="5">
                  <c:v>-117</c:v>
                </c:pt>
                <c:pt idx="6">
                  <c:v>-97</c:v>
                </c:pt>
                <c:pt idx="7">
                  <c:v>-77</c:v>
                </c:pt>
                <c:pt idx="8">
                  <c:v>-57</c:v>
                </c:pt>
                <c:pt idx="9">
                  <c:v>-37</c:v>
                </c:pt>
                <c:pt idx="10">
                  <c:v>-17</c:v>
                </c:pt>
                <c:pt idx="11">
                  <c:v>3</c:v>
                </c:pt>
                <c:pt idx="12">
                  <c:v>23</c:v>
                </c:pt>
                <c:pt idx="13">
                  <c:v>43</c:v>
                </c:pt>
              </c:numCache>
            </c:numRef>
          </c:xVal>
          <c:yVal>
            <c:numRef>
              <c:f>Sheet1!$H$74:$H$87</c:f>
              <c:numCache>
                <c:formatCode>General</c:formatCode>
                <c:ptCount val="14"/>
                <c:pt idx="0">
                  <c:v>-105.29510000000001</c:v>
                </c:pt>
                <c:pt idx="1">
                  <c:v>-93.006799999999998</c:v>
                </c:pt>
                <c:pt idx="2">
                  <c:v>-82.382400000000004</c:v>
                </c:pt>
                <c:pt idx="3">
                  <c:v>-70.821200000000005</c:v>
                </c:pt>
                <c:pt idx="4">
                  <c:v>-59.940100000000001</c:v>
                </c:pt>
                <c:pt idx="5">
                  <c:v>-49.550899999999999</c:v>
                </c:pt>
                <c:pt idx="6">
                  <c:v>-39.379800000000003</c:v>
                </c:pt>
                <c:pt idx="7">
                  <c:v>-28.840900000000001</c:v>
                </c:pt>
                <c:pt idx="8">
                  <c:v>-16.9376</c:v>
                </c:pt>
                <c:pt idx="9">
                  <c:v>-4.2301000000000002</c:v>
                </c:pt>
                <c:pt idx="10">
                  <c:v>10.7784</c:v>
                </c:pt>
                <c:pt idx="11">
                  <c:v>29.653500000000001</c:v>
                </c:pt>
                <c:pt idx="12">
                  <c:v>52.065899999999999</c:v>
                </c:pt>
                <c:pt idx="13">
                  <c:v>79.14459999999999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E114-42E8-A1A7-02CC8B32FC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227040"/>
        <c:axId val="-208219424"/>
      </c:scatterChart>
      <c:valAx>
        <c:axId val="-2082270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 dirty="0" err="1" smtClean="0">
                    <a:solidFill>
                      <a:schemeClr val="tx1"/>
                    </a:solidFill>
                  </a:rPr>
                  <a:t>Vm</a:t>
                </a:r>
                <a:r>
                  <a:rPr lang="en-GB" b="1" baseline="0" dirty="0" smtClean="0">
                    <a:solidFill>
                      <a:schemeClr val="tx1"/>
                    </a:solidFill>
                  </a:rPr>
                  <a:t> (mV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3916907359428496E-2"/>
              <c:y val="0.348029814339664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219424"/>
        <c:crosses val="autoZero"/>
        <c:crossBetween val="midCat"/>
      </c:valAx>
      <c:valAx>
        <c:axId val="-208219424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 dirty="0" smtClean="0">
                    <a:solidFill>
                      <a:schemeClr val="tx1"/>
                    </a:solidFill>
                  </a:rPr>
                  <a:t>I</a:t>
                </a:r>
                <a:r>
                  <a:rPr lang="en-GB" b="1" baseline="0" dirty="0" smtClean="0">
                    <a:solidFill>
                      <a:schemeClr val="tx1"/>
                    </a:solidFill>
                  </a:rPr>
                  <a:t> (</a:t>
                </a:r>
                <a:r>
                  <a:rPr lang="en-GB" b="1" baseline="0" dirty="0" err="1" smtClean="0">
                    <a:solidFill>
                      <a:schemeClr val="tx1"/>
                    </a:solidFill>
                  </a:rPr>
                  <a:t>pA</a:t>
                </a:r>
                <a:r>
                  <a:rPr lang="en-GB" b="1" baseline="0" dirty="0" smtClean="0">
                    <a:solidFill>
                      <a:schemeClr val="tx1"/>
                    </a:solidFill>
                  </a:rPr>
                  <a:t>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63191124695972456"/>
              <c:y val="1.923503600452167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82270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8806644965530006"/>
          <c:y val="8.7669517094243699E-2"/>
          <c:w val="0.40927950812470615"/>
          <c:h val="0.2109340920711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9043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0640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5935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9862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5444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565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529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8475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2184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484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83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16DD4-B4CD-4D95-89D0-7A27E24A6B81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6E5C51-9F20-4292-8B8C-C1DC50205D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1563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1390170"/>
              </p:ext>
            </p:extLst>
          </p:nvPr>
        </p:nvGraphicFramePr>
        <p:xfrm>
          <a:off x="764495" y="588622"/>
          <a:ext cx="3667124" cy="2690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5048167"/>
              </p:ext>
            </p:extLst>
          </p:nvPr>
        </p:nvGraphicFramePr>
        <p:xfrm>
          <a:off x="4714875" y="621052"/>
          <a:ext cx="3653745" cy="2681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图表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4762763"/>
              </p:ext>
            </p:extLst>
          </p:nvPr>
        </p:nvGraphicFramePr>
        <p:xfrm>
          <a:off x="782864" y="3629705"/>
          <a:ext cx="3667125" cy="2633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图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0305221"/>
              </p:ext>
            </p:extLst>
          </p:nvPr>
        </p:nvGraphicFramePr>
        <p:xfrm>
          <a:off x="4702266" y="3909060"/>
          <a:ext cx="3630839" cy="2583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Rectangle 1"/>
          <p:cNvSpPr/>
          <p:nvPr/>
        </p:nvSpPr>
        <p:spPr>
          <a:xfrm>
            <a:off x="8274572" y="2698030"/>
            <a:ext cx="3785136" cy="1723549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algn="just">
              <a:spcAft>
                <a:spcPts val="600"/>
              </a:spcAft>
            </a:pPr>
            <a:r>
              <a:rPr lang="en-GB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. Activation of the anion conductance by</a:t>
            </a:r>
          </a:p>
          <a:p>
            <a:pPr lvl="0" algn="just">
              <a:spcAft>
                <a:spcPts val="600"/>
              </a:spcAft>
            </a:pPr>
            <a:r>
              <a:rPr lang="en-GB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TP</a:t>
            </a:r>
            <a:r>
              <a:rPr lang="en-GB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/V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onships from whole-cell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ings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 the PM</a:t>
            </a:r>
          </a:p>
          <a:p>
            <a:pPr lvl="0" algn="just"/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ion conductance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fore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lue) and 3 minutes after </a:t>
            </a:r>
          </a:p>
          <a:p>
            <a:pPr lvl="0" algn="just"/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orange) the addition of  300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µM ATP. Data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e from the</a:t>
            </a:r>
          </a:p>
          <a:p>
            <a:pPr lvl="0" algn="just"/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r protoplasts used to generate the mean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/V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onship</a:t>
            </a:r>
          </a:p>
          <a:p>
            <a:pPr lvl="0" algn="just"/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wn in Figure 1C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rding protocols were as in </a:t>
            </a:r>
            <a:endParaRPr lang="en-US" altLang="zh-CN" sz="1200" dirty="0" smtClea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8829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106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min</dc:creator>
  <cp:lastModifiedBy>Group</cp:lastModifiedBy>
  <cp:revision>16</cp:revision>
  <dcterms:created xsi:type="dcterms:W3CDTF">2019-06-03T19:33:04Z</dcterms:created>
  <dcterms:modified xsi:type="dcterms:W3CDTF">2019-06-05T19:36:55Z</dcterms:modified>
</cp:coreProperties>
</file>